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54" r:id="rId2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98" autoAdjust="0"/>
    <p:restoredTop sz="88946" autoAdjust="0"/>
  </p:normalViewPr>
  <p:slideViewPr>
    <p:cSldViewPr snapToGrid="0">
      <p:cViewPr>
        <p:scale>
          <a:sx n="50" d="100"/>
          <a:sy n="50" d="100"/>
        </p:scale>
        <p:origin x="2196" y="-416"/>
      </p:cViewPr>
      <p:guideLst>
        <p:guide orient="horz" pos="4032"/>
        <p:guide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7913D6-0FD2-4980-B6AE-8F707D3D53F1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025F01-33C1-430D-A828-9C18B69C2E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4405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lementary Figure S4. Kaplan-Meier curves of overall survival according to Child-Pugh class, up-to-seven criteria and des-</a:t>
            </a:r>
            <a:r>
              <a:rPr kumimoji="1" lang="el-GR" altLang="ja-JP" dirty="0"/>
              <a:t>γ-</a:t>
            </a:r>
            <a:r>
              <a:rPr kumimoji="1" lang="en-US" altLang="ja-JP" dirty="0"/>
              <a:t>carboxy prothrombin (DCP</a:t>
            </a:r>
            <a:r>
              <a:rPr kumimoji="1" lang="en-US" altLang="ja-JP"/>
              <a:t>) levels</a:t>
            </a:r>
            <a:endParaRPr kumimoji="1" lang="ja-JP" altLang="en-US" b="1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C025F01-33C1-430D-A828-9C18B69C2E2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46966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51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032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4064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485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442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9937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6368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9123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207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4551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5204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E4DD5E-85B3-4ED7-8257-C85BAF12B2C5}" type="datetimeFigureOut">
              <a:rPr kumimoji="1" lang="ja-JP" altLang="en-US" smtClean="0"/>
              <a:t>2024/3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82017D-F864-4F8A-9D0F-7C820F94A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461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318DE1A-A876-8866-F66C-13A8B1A29FC9}"/>
              </a:ext>
            </a:extLst>
          </p:cNvPr>
          <p:cNvSpPr txBox="1"/>
          <p:nvPr/>
        </p:nvSpPr>
        <p:spPr>
          <a:xfrm>
            <a:off x="0" y="252804"/>
            <a:ext cx="32004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18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S4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A6CB743F-4E34-5164-35F0-2D2161D544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987" y="5087319"/>
            <a:ext cx="4649592" cy="3235069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4FF03E88-A4ED-E6A9-3321-C5CFBC523F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53090" y="1035278"/>
            <a:ext cx="4649591" cy="323506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F40092AD-0D44-F7E9-FC39-F787B62243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505" y="1044494"/>
            <a:ext cx="4649591" cy="3235069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5FBAC81-20A6-F626-0D00-C7C5D5B3EFF0}"/>
              </a:ext>
            </a:extLst>
          </p:cNvPr>
          <p:cNvSpPr txBox="1"/>
          <p:nvPr/>
        </p:nvSpPr>
        <p:spPr>
          <a:xfrm>
            <a:off x="1408154" y="2966905"/>
            <a:ext cx="1046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 = 0.0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C24E04A-B80F-F910-19DE-30537823146B}"/>
              </a:ext>
            </a:extLst>
          </p:cNvPr>
          <p:cNvSpPr txBox="1"/>
          <p:nvPr/>
        </p:nvSpPr>
        <p:spPr>
          <a:xfrm>
            <a:off x="885587" y="824391"/>
            <a:ext cx="366614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hild-Pugh Clas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1EE6CE5-8FEF-0061-3B92-C4B53F731F04}"/>
              </a:ext>
            </a:extLst>
          </p:cNvPr>
          <p:cNvSpPr txBox="1"/>
          <p:nvPr/>
        </p:nvSpPr>
        <p:spPr>
          <a:xfrm>
            <a:off x="1414238" y="7068504"/>
            <a:ext cx="1046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 = 0.0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E2A0C26-0AAD-DFF6-27F8-BC64EA944BEE}"/>
              </a:ext>
            </a:extLst>
          </p:cNvPr>
          <p:cNvSpPr txBox="1"/>
          <p:nvPr/>
        </p:nvSpPr>
        <p:spPr>
          <a:xfrm>
            <a:off x="5740631" y="2904586"/>
            <a:ext cx="1046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 = 0.0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18A96CAE-1A17-D576-1B9B-365EAA8CFF75}"/>
              </a:ext>
            </a:extLst>
          </p:cNvPr>
          <p:cNvGrpSpPr/>
          <p:nvPr/>
        </p:nvGrpSpPr>
        <p:grpSpPr>
          <a:xfrm>
            <a:off x="3820528" y="1526080"/>
            <a:ext cx="587611" cy="440472"/>
            <a:chOff x="2285999" y="1014822"/>
            <a:chExt cx="587611" cy="440472"/>
          </a:xfrm>
          <a:solidFill>
            <a:schemeClr val="bg1"/>
          </a:solidFill>
        </p:grpSpPr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11BB8AFF-963D-9C7A-047F-621C7EADFC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5480" t="16058" r="16972" b="78281"/>
            <a:stretch/>
          </p:blipFill>
          <p:spPr>
            <a:xfrm>
              <a:off x="2285999" y="1074420"/>
              <a:ext cx="438573" cy="328930"/>
            </a:xfrm>
            <a:prstGeom prst="rect">
              <a:avLst/>
            </a:prstGeom>
            <a:grpFill/>
          </p:spPr>
        </p:pic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2DD34C24-A56D-8933-A881-71F5BD87ACA0}"/>
                </a:ext>
              </a:extLst>
            </p:cNvPr>
            <p:cNvSpPr txBox="1"/>
            <p:nvPr/>
          </p:nvSpPr>
          <p:spPr>
            <a:xfrm>
              <a:off x="2596845" y="1014822"/>
              <a:ext cx="272832" cy="25391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1050" dirty="0"/>
                <a:t>A</a:t>
              </a:r>
              <a:endParaRPr kumimoji="1" lang="ja-JP" altLang="en-US" sz="105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3100D0DA-8EDD-58EF-0E1F-B4C287C28CCB}"/>
                </a:ext>
              </a:extLst>
            </p:cNvPr>
            <p:cNvSpPr txBox="1"/>
            <p:nvPr/>
          </p:nvSpPr>
          <p:spPr>
            <a:xfrm>
              <a:off x="2597572" y="1201378"/>
              <a:ext cx="276038" cy="25391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/>
                <a:t>B</a:t>
              </a:r>
              <a:endParaRPr kumimoji="1" lang="ja-JP" altLang="en-US" sz="1050" dirty="0"/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B4EE3C3A-77A0-29BA-DCC9-7CB0FA684820}"/>
              </a:ext>
            </a:extLst>
          </p:cNvPr>
          <p:cNvGrpSpPr/>
          <p:nvPr/>
        </p:nvGrpSpPr>
        <p:grpSpPr>
          <a:xfrm>
            <a:off x="3714483" y="5352913"/>
            <a:ext cx="784779" cy="440472"/>
            <a:chOff x="2285999" y="1014822"/>
            <a:chExt cx="784779" cy="440472"/>
          </a:xfrm>
          <a:solidFill>
            <a:schemeClr val="bg1"/>
          </a:solidFill>
        </p:grpSpPr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9EB1936B-A337-FD36-FC61-4C1F2B1FCE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5480" t="16058" r="16972" b="78281"/>
            <a:stretch/>
          </p:blipFill>
          <p:spPr>
            <a:xfrm>
              <a:off x="2285999" y="1074420"/>
              <a:ext cx="438573" cy="328930"/>
            </a:xfrm>
            <a:prstGeom prst="rect">
              <a:avLst/>
            </a:prstGeom>
            <a:grpFill/>
          </p:spPr>
        </p:pic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3B1F1B23-9B81-9DD0-AC7F-7C00D81CE553}"/>
                </a:ext>
              </a:extLst>
            </p:cNvPr>
            <p:cNvSpPr txBox="1"/>
            <p:nvPr/>
          </p:nvSpPr>
          <p:spPr>
            <a:xfrm>
              <a:off x="2596845" y="1014822"/>
              <a:ext cx="444352" cy="25391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/>
                <a:t>Low</a:t>
              </a:r>
              <a:endParaRPr kumimoji="1" lang="ja-JP" altLang="en-US" sz="1050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FBEA4054-9F9D-CCF9-6ABA-45B9CAA48F48}"/>
                </a:ext>
              </a:extLst>
            </p:cNvPr>
            <p:cNvSpPr txBox="1"/>
            <p:nvPr/>
          </p:nvSpPr>
          <p:spPr>
            <a:xfrm>
              <a:off x="2597572" y="1201378"/>
              <a:ext cx="473206" cy="25391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1050" dirty="0"/>
                <a:t>High</a:t>
              </a:r>
              <a:endParaRPr kumimoji="1" lang="ja-JP" altLang="en-US" sz="1050" dirty="0"/>
            </a:p>
          </p:txBody>
        </p: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880944FC-5E05-B157-EDF6-476BCFF10C0B}"/>
              </a:ext>
            </a:extLst>
          </p:cNvPr>
          <p:cNvGrpSpPr/>
          <p:nvPr/>
        </p:nvGrpSpPr>
        <p:grpSpPr>
          <a:xfrm>
            <a:off x="8493704" y="1267192"/>
            <a:ext cx="697490" cy="452737"/>
            <a:chOff x="2285999" y="1014822"/>
            <a:chExt cx="697490" cy="452737"/>
          </a:xfrm>
          <a:solidFill>
            <a:schemeClr val="bg1"/>
          </a:solidFill>
        </p:grpSpPr>
        <p:pic>
          <p:nvPicPr>
            <p:cNvPr id="29" name="図 28">
              <a:extLst>
                <a:ext uri="{FF2B5EF4-FFF2-40B4-BE49-F238E27FC236}">
                  <a16:creationId xmlns:a16="http://schemas.microsoft.com/office/drawing/2014/main" id="{66F2E7B9-7E38-F9D1-2058-4666D2E512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5480" t="16058" r="16972" b="78281"/>
            <a:stretch/>
          </p:blipFill>
          <p:spPr>
            <a:xfrm>
              <a:off x="2285999" y="1074420"/>
              <a:ext cx="438573" cy="328930"/>
            </a:xfrm>
            <a:prstGeom prst="rect">
              <a:avLst/>
            </a:prstGeom>
            <a:grpFill/>
          </p:spPr>
        </p:pic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0A3DC340-9459-2DE6-F67D-B8F3366CB460}"/>
                </a:ext>
              </a:extLst>
            </p:cNvPr>
            <p:cNvSpPr txBox="1"/>
            <p:nvPr/>
          </p:nvSpPr>
          <p:spPr>
            <a:xfrm>
              <a:off x="2596845" y="1014822"/>
              <a:ext cx="298480" cy="25391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1050" dirty="0"/>
                <a:t>in</a:t>
              </a:r>
              <a:endParaRPr kumimoji="1" lang="ja-JP" altLang="en-US" sz="1050" dirty="0"/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D22D8A74-959D-8B3D-E4AF-A62BDE31C021}"/>
                </a:ext>
              </a:extLst>
            </p:cNvPr>
            <p:cNvSpPr txBox="1"/>
            <p:nvPr/>
          </p:nvSpPr>
          <p:spPr>
            <a:xfrm>
              <a:off x="2596845" y="1213643"/>
              <a:ext cx="386644" cy="25391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/>
                <a:t>out</a:t>
              </a:r>
              <a:endParaRPr kumimoji="1" lang="ja-JP" altLang="en-US" sz="1050" dirty="0"/>
            </a:p>
          </p:txBody>
        </p:sp>
      </p:grp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4720D0A-9361-E214-2336-3BF032409F4C}"/>
              </a:ext>
            </a:extLst>
          </p:cNvPr>
          <p:cNvSpPr txBox="1"/>
          <p:nvPr/>
        </p:nvSpPr>
        <p:spPr>
          <a:xfrm>
            <a:off x="907153" y="4859291"/>
            <a:ext cx="366614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CP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DCF8DE6-8417-738D-14DA-DF9BE62C0BB1}"/>
              </a:ext>
            </a:extLst>
          </p:cNvPr>
          <p:cNvSpPr txBox="1"/>
          <p:nvPr/>
        </p:nvSpPr>
        <p:spPr>
          <a:xfrm>
            <a:off x="5679206" y="812112"/>
            <a:ext cx="366614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>
                <a:latin typeface="Arial" panose="020B0604020202020204" pitchFamily="34" charset="0"/>
                <a:cs typeface="Arial" panose="020B0604020202020204" pitchFamily="34" charset="0"/>
              </a:rPr>
              <a:t>Up-to-seve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61A6538-173E-8261-A553-36E16859CABF}"/>
              </a:ext>
            </a:extLst>
          </p:cNvPr>
          <p:cNvSpPr txBox="1"/>
          <p:nvPr/>
        </p:nvSpPr>
        <p:spPr>
          <a:xfrm rot="16200000">
            <a:off x="-804573" y="2186780"/>
            <a:ext cx="235022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Overall survival (%)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234A9C8-A2E9-9B1F-EDA2-33BEA55EA98A}"/>
              </a:ext>
            </a:extLst>
          </p:cNvPr>
          <p:cNvSpPr txBox="1"/>
          <p:nvPr/>
        </p:nvSpPr>
        <p:spPr>
          <a:xfrm>
            <a:off x="896800" y="3821270"/>
            <a:ext cx="367052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ime (months)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FA4FAD5A-9F94-A961-0F2E-0933A6053BCE}"/>
              </a:ext>
            </a:extLst>
          </p:cNvPr>
          <p:cNvSpPr txBox="1"/>
          <p:nvPr/>
        </p:nvSpPr>
        <p:spPr>
          <a:xfrm rot="16200000">
            <a:off x="-794221" y="6242324"/>
            <a:ext cx="235022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Overall survival (%)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CC8FC0A0-0262-A262-567A-528C0F89B977}"/>
              </a:ext>
            </a:extLst>
          </p:cNvPr>
          <p:cNvSpPr txBox="1"/>
          <p:nvPr/>
        </p:nvSpPr>
        <p:spPr>
          <a:xfrm>
            <a:off x="907152" y="7876814"/>
            <a:ext cx="367052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ime (months)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CE633C8-DC3B-E87D-A66A-ABB48A9F7E26}"/>
              </a:ext>
            </a:extLst>
          </p:cNvPr>
          <p:cNvSpPr txBox="1"/>
          <p:nvPr/>
        </p:nvSpPr>
        <p:spPr>
          <a:xfrm rot="16200000">
            <a:off x="3980996" y="2181814"/>
            <a:ext cx="235022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Overall survival (%)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DFB14191-AE7A-3009-4DAD-83F944FD880A}"/>
              </a:ext>
            </a:extLst>
          </p:cNvPr>
          <p:cNvSpPr txBox="1"/>
          <p:nvPr/>
        </p:nvSpPr>
        <p:spPr>
          <a:xfrm>
            <a:off x="5682369" y="3816304"/>
            <a:ext cx="367052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ime (months)</a:t>
            </a:r>
          </a:p>
        </p:txBody>
      </p:sp>
      <p:graphicFrame>
        <p:nvGraphicFramePr>
          <p:cNvPr id="42" name="表 41">
            <a:extLst>
              <a:ext uri="{FF2B5EF4-FFF2-40B4-BE49-F238E27FC236}">
                <a16:creationId xmlns:a16="http://schemas.microsoft.com/office/drawing/2014/main" id="{D0A00E6D-5DFB-DBB9-FADF-72E54BB6FC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969482"/>
              </p:ext>
            </p:extLst>
          </p:nvPr>
        </p:nvGraphicFramePr>
        <p:xfrm>
          <a:off x="145279" y="3878837"/>
          <a:ext cx="4406453" cy="6584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7915">
                  <a:extLst>
                    <a:ext uri="{9D8B030D-6E8A-4147-A177-3AD203B41FA5}">
                      <a16:colId xmlns:a16="http://schemas.microsoft.com/office/drawing/2014/main" val="1905080526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653500166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191184691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3183796512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399036275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52594267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769717267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30560971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4035839007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198670413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928569976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951702494"/>
                    </a:ext>
                  </a:extLst>
                </a:gridCol>
              </a:tblGrid>
              <a:tr h="214792">
                <a:tc gridSpan="12"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　</a:t>
                      </a: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at risk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Number at risk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extLst>
                  <a:ext uri="{0D108BD9-81ED-4DB2-BD59-A6C34878D82A}">
                    <a16:rowId xmlns:a16="http://schemas.microsoft.com/office/drawing/2014/main" val="4094843110"/>
                  </a:ext>
                </a:extLst>
              </a:tr>
              <a:tr h="2157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8311551"/>
                  </a:ext>
                </a:extLst>
              </a:tr>
              <a:tr h="2157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9114221"/>
                  </a:ext>
                </a:extLst>
              </a:tr>
            </a:tbl>
          </a:graphicData>
        </a:graphic>
      </p:graphicFrame>
      <p:graphicFrame>
        <p:nvGraphicFramePr>
          <p:cNvPr id="43" name="表 42">
            <a:extLst>
              <a:ext uri="{FF2B5EF4-FFF2-40B4-BE49-F238E27FC236}">
                <a16:creationId xmlns:a16="http://schemas.microsoft.com/office/drawing/2014/main" id="{7FAE50EA-CA8D-4943-B42A-70792157FA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8228560"/>
              </p:ext>
            </p:extLst>
          </p:nvPr>
        </p:nvGraphicFramePr>
        <p:xfrm>
          <a:off x="38798" y="7915766"/>
          <a:ext cx="4406453" cy="6584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7915">
                  <a:extLst>
                    <a:ext uri="{9D8B030D-6E8A-4147-A177-3AD203B41FA5}">
                      <a16:colId xmlns:a16="http://schemas.microsoft.com/office/drawing/2014/main" val="1905080526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653500166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191184691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3183796512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399036275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52594267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769717267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30560971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4035839007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198670413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928569976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951702494"/>
                    </a:ext>
                  </a:extLst>
                </a:gridCol>
              </a:tblGrid>
              <a:tr h="214792">
                <a:tc gridSpan="12"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　</a:t>
                      </a: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at risk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Number at risk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extLst>
                  <a:ext uri="{0D108BD9-81ED-4DB2-BD59-A6C34878D82A}">
                    <a16:rowId xmlns:a16="http://schemas.microsoft.com/office/drawing/2014/main" val="4094843110"/>
                  </a:ext>
                </a:extLst>
              </a:tr>
              <a:tr h="2157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8311551"/>
                  </a:ext>
                </a:extLst>
              </a:tr>
              <a:tr h="2157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9114221"/>
                  </a:ext>
                </a:extLst>
              </a:tr>
            </a:tbl>
          </a:graphicData>
        </a:graphic>
      </p:graphicFrame>
      <p:graphicFrame>
        <p:nvGraphicFramePr>
          <p:cNvPr id="44" name="表 43">
            <a:extLst>
              <a:ext uri="{FF2B5EF4-FFF2-40B4-BE49-F238E27FC236}">
                <a16:creationId xmlns:a16="http://schemas.microsoft.com/office/drawing/2014/main" id="{2F678F14-3F52-193E-C3C9-9201B0AE58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9374334"/>
              </p:ext>
            </p:extLst>
          </p:nvPr>
        </p:nvGraphicFramePr>
        <p:xfrm>
          <a:off x="4849462" y="3897821"/>
          <a:ext cx="4406453" cy="6584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7915">
                  <a:extLst>
                    <a:ext uri="{9D8B030D-6E8A-4147-A177-3AD203B41FA5}">
                      <a16:colId xmlns:a16="http://schemas.microsoft.com/office/drawing/2014/main" val="1905080526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653500166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191184691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3183796512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399036275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52594267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769717267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30560971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4035839007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1986704135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928569976"/>
                    </a:ext>
                  </a:extLst>
                </a:gridCol>
                <a:gridCol w="338958">
                  <a:extLst>
                    <a:ext uri="{9D8B030D-6E8A-4147-A177-3AD203B41FA5}">
                      <a16:colId xmlns:a16="http://schemas.microsoft.com/office/drawing/2014/main" val="2951702494"/>
                    </a:ext>
                  </a:extLst>
                </a:gridCol>
              </a:tblGrid>
              <a:tr h="214792">
                <a:tc gridSpan="12"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　</a:t>
                      </a: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at risk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Number at risk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125" marR="6125" marT="6125" marB="0" anchor="ctr"/>
                </a:tc>
                <a:extLst>
                  <a:ext uri="{0D108BD9-81ED-4DB2-BD59-A6C34878D82A}">
                    <a16:rowId xmlns:a16="http://schemas.microsoft.com/office/drawing/2014/main" val="4094843110"/>
                  </a:ext>
                </a:extLst>
              </a:tr>
              <a:tr h="2157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8311551"/>
                  </a:ext>
                </a:extLst>
              </a:tr>
              <a:tr h="2157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ut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125" marR="6125" marT="61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9114221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09D95904-8F57-B17C-10DA-382850A56F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3631469"/>
              </p:ext>
            </p:extLst>
          </p:nvPr>
        </p:nvGraphicFramePr>
        <p:xfrm>
          <a:off x="450380" y="969463"/>
          <a:ext cx="360048" cy="280714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60048">
                  <a:extLst>
                    <a:ext uri="{9D8B030D-6E8A-4147-A177-3AD203B41FA5}">
                      <a16:colId xmlns:a16="http://schemas.microsoft.com/office/drawing/2014/main" val="1905080526"/>
                    </a:ext>
                  </a:extLst>
                </a:gridCol>
              </a:tblGrid>
              <a:tr h="438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8398826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3212788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709873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4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6492905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2706864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7686660"/>
                  </a:ext>
                </a:extLst>
              </a:tr>
            </a:tbl>
          </a:graphicData>
        </a:graphic>
      </p:graphicFrame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F47B342D-EBA3-CAB4-9459-DFFD520E8B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9446221"/>
              </p:ext>
            </p:extLst>
          </p:nvPr>
        </p:nvGraphicFramePr>
        <p:xfrm>
          <a:off x="731073" y="3608423"/>
          <a:ext cx="3699542" cy="22048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36322">
                  <a:extLst>
                    <a:ext uri="{9D8B030D-6E8A-4147-A177-3AD203B41FA5}">
                      <a16:colId xmlns:a16="http://schemas.microsoft.com/office/drawing/2014/main" val="1905080526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653500166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191184691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3183796512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399036275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252594267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769717267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230560971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4035839007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198670413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2928569976"/>
                    </a:ext>
                  </a:extLst>
                </a:gridCol>
              </a:tblGrid>
              <a:tr h="2204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5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5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9114221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F8F8823D-B130-99F5-8504-43E66F9926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7545751"/>
              </p:ext>
            </p:extLst>
          </p:nvPr>
        </p:nvGraphicFramePr>
        <p:xfrm>
          <a:off x="5240820" y="959303"/>
          <a:ext cx="360048" cy="280714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60048">
                  <a:extLst>
                    <a:ext uri="{9D8B030D-6E8A-4147-A177-3AD203B41FA5}">
                      <a16:colId xmlns:a16="http://schemas.microsoft.com/office/drawing/2014/main" val="1905080526"/>
                    </a:ext>
                  </a:extLst>
                </a:gridCol>
              </a:tblGrid>
              <a:tr h="438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8398826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3212788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709873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4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6492905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2706864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7686660"/>
                  </a:ext>
                </a:extLst>
              </a:tr>
            </a:tbl>
          </a:graphicData>
        </a:graphic>
      </p:graphicFrame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DABC0705-8963-667A-1212-07BCE46E6C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1599624"/>
              </p:ext>
            </p:extLst>
          </p:nvPr>
        </p:nvGraphicFramePr>
        <p:xfrm>
          <a:off x="5511353" y="3598263"/>
          <a:ext cx="3699542" cy="22048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36322">
                  <a:extLst>
                    <a:ext uri="{9D8B030D-6E8A-4147-A177-3AD203B41FA5}">
                      <a16:colId xmlns:a16="http://schemas.microsoft.com/office/drawing/2014/main" val="1905080526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653500166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191184691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3183796512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399036275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252594267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769717267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230560971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4035839007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198670413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2928569976"/>
                    </a:ext>
                  </a:extLst>
                </a:gridCol>
              </a:tblGrid>
              <a:tr h="2204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5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5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9114221"/>
                  </a:ext>
                </a:extLst>
              </a:tr>
            </a:tbl>
          </a:graphicData>
        </a:graphic>
      </p:graphicFrame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774E4BF7-6902-1F33-EFF8-EEB93959FA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9313439"/>
              </p:ext>
            </p:extLst>
          </p:nvPr>
        </p:nvGraphicFramePr>
        <p:xfrm>
          <a:off x="482539" y="4997916"/>
          <a:ext cx="360048" cy="280714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60048">
                  <a:extLst>
                    <a:ext uri="{9D8B030D-6E8A-4147-A177-3AD203B41FA5}">
                      <a16:colId xmlns:a16="http://schemas.microsoft.com/office/drawing/2014/main" val="1905080526"/>
                    </a:ext>
                  </a:extLst>
                </a:gridCol>
              </a:tblGrid>
              <a:tr h="4383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8398826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3212788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709873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4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6492905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2706864"/>
                  </a:ext>
                </a:extLst>
              </a:tr>
              <a:tr h="4737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7686660"/>
                  </a:ext>
                </a:extLst>
              </a:tr>
            </a:tbl>
          </a:graphicData>
        </a:graphic>
      </p:graphicFrame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5CD9482E-5156-F209-2A22-1F903C8091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0686474"/>
              </p:ext>
            </p:extLst>
          </p:nvPr>
        </p:nvGraphicFramePr>
        <p:xfrm>
          <a:off x="744605" y="7636876"/>
          <a:ext cx="3699542" cy="22048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36322">
                  <a:extLst>
                    <a:ext uri="{9D8B030D-6E8A-4147-A177-3AD203B41FA5}">
                      <a16:colId xmlns:a16="http://schemas.microsoft.com/office/drawing/2014/main" val="1905080526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653500166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191184691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3183796512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399036275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252594267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769717267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230560971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4035839007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1986704135"/>
                    </a:ext>
                  </a:extLst>
                </a:gridCol>
                <a:gridCol w="336322">
                  <a:extLst>
                    <a:ext uri="{9D8B030D-6E8A-4147-A177-3AD203B41FA5}">
                      <a16:colId xmlns:a16="http://schemas.microsoft.com/office/drawing/2014/main" val="2928569976"/>
                    </a:ext>
                  </a:extLst>
                </a:gridCol>
              </a:tblGrid>
              <a:tr h="2204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5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5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125" marR="6125" marT="61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91142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52526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3627</TotalTime>
  <Words>159</Words>
  <Application>Microsoft Office PowerPoint</Application>
  <PresentationFormat>A3 297x420 mm</PresentationFormat>
  <Paragraphs>10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佑樹 白根</cp:lastModifiedBy>
  <cp:revision>267</cp:revision>
  <dcterms:created xsi:type="dcterms:W3CDTF">2023-02-03T10:40:40Z</dcterms:created>
  <dcterms:modified xsi:type="dcterms:W3CDTF">2024-03-14T03:07:15Z</dcterms:modified>
</cp:coreProperties>
</file>